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8746A-AD50-4C9C-A232-2B0FAAAC4C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A9BD5-C1D6-4810-9E0E-F669B3DE83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86BF4-AD6D-4C6F-87FF-BDE389B8B6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A38CB-4136-4070-AB48-7F51812B26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89274-07EB-49BC-A753-FD1CE0CED6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9D3FF6-06A0-4B9C-B23F-88E3534012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18FDF-AF04-4EAF-8400-6B016CBF10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757983-5CDF-4F32-A3A6-558F83CC06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3E03E-BF71-4D10-8FED-1056D34C0A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382D2-B4E6-4FA3-A43B-8435FB59D7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B4AF5-CEF0-430F-976E-CF3DAF4A1C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24332-13C6-4578-AB42-37AA5A15A8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4A943E-6CB6-4FDA-84D4-E876600903B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1147680" y="152280"/>
            <a:ext cx="251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efore  insect bio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5494320" y="152280"/>
            <a:ext cx="251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fter  insect bioass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1"/>
          <p:cNvSpPr/>
          <p:nvPr/>
        </p:nvSpPr>
        <p:spPr>
          <a:xfrm>
            <a:off x="573120" y="6324480"/>
            <a:ext cx="83818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 Control and T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geny of transgenic lines of Ab25 C, Ab25 B, Ab25 A, Ab25 D and Ab25 E subjected to feeding assay by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. armiger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 Fruit  damage was calculated by fruit weight metho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1" descr="C:\Documents and Settings\a\Desktop\Picture1.tif"/>
          <p:cNvPicPr/>
          <p:nvPr/>
        </p:nvPicPr>
        <p:blipFill>
          <a:blip r:embed="rId1"/>
          <a:stretch/>
        </p:blipFill>
        <p:spPr>
          <a:xfrm>
            <a:off x="155520" y="382680"/>
            <a:ext cx="8832960" cy="5956200"/>
          </a:xfrm>
          <a:prstGeom prst="rect">
            <a:avLst/>
          </a:prstGeom>
          <a:ln w="0">
            <a:noFill/>
          </a:ln>
        </p:spPr>
      </p:pic>
      <p:grpSp>
        <p:nvGrpSpPr>
          <p:cNvPr id="45" name="Group 18"/>
          <p:cNvGrpSpPr/>
          <p:nvPr/>
        </p:nvGrpSpPr>
        <p:grpSpPr>
          <a:xfrm>
            <a:off x="41400" y="846000"/>
            <a:ext cx="807840" cy="5090760"/>
            <a:chOff x="41400" y="846000"/>
            <a:chExt cx="807840" cy="5090760"/>
          </a:xfrm>
        </p:grpSpPr>
        <p:sp>
          <p:nvSpPr>
            <p:cNvPr id="46" name="TextBox 11"/>
            <p:cNvSpPr/>
            <p:nvPr/>
          </p:nvSpPr>
          <p:spPr>
            <a:xfrm>
              <a:off x="41400" y="846000"/>
              <a:ext cx="807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2"/>
            <p:cNvSpPr/>
            <p:nvPr/>
          </p:nvSpPr>
          <p:spPr>
            <a:xfrm>
              <a:off x="109440" y="281952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3"/>
            <p:cNvSpPr/>
            <p:nvPr/>
          </p:nvSpPr>
          <p:spPr>
            <a:xfrm>
              <a:off x="114120" y="464832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4"/>
            <p:cNvSpPr/>
            <p:nvPr/>
          </p:nvSpPr>
          <p:spPr>
            <a:xfrm>
              <a:off x="103680" y="374112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5"/>
            <p:cNvSpPr/>
            <p:nvPr/>
          </p:nvSpPr>
          <p:spPr>
            <a:xfrm>
              <a:off x="117360" y="566028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7"/>
            <p:cNvSpPr/>
            <p:nvPr/>
          </p:nvSpPr>
          <p:spPr>
            <a:xfrm>
              <a:off x="117360" y="1850400"/>
              <a:ext cx="68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Group 19"/>
          <p:cNvGrpSpPr/>
          <p:nvPr/>
        </p:nvGrpSpPr>
        <p:grpSpPr>
          <a:xfrm>
            <a:off x="4370400" y="847800"/>
            <a:ext cx="749160" cy="5092200"/>
            <a:chOff x="4370400" y="847800"/>
            <a:chExt cx="749160" cy="5092200"/>
          </a:xfrm>
        </p:grpSpPr>
        <p:sp>
          <p:nvSpPr>
            <p:cNvPr id="53" name="TextBox 20"/>
            <p:cNvSpPr/>
            <p:nvPr/>
          </p:nvSpPr>
          <p:spPr>
            <a:xfrm>
              <a:off x="4370400" y="847800"/>
              <a:ext cx="705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1"/>
            <p:cNvSpPr/>
            <p:nvPr/>
          </p:nvSpPr>
          <p:spPr>
            <a:xfrm>
              <a:off x="4424760" y="2821680"/>
              <a:ext cx="68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2"/>
            <p:cNvSpPr/>
            <p:nvPr/>
          </p:nvSpPr>
          <p:spPr>
            <a:xfrm>
              <a:off x="4429440" y="4651200"/>
              <a:ext cx="68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3"/>
            <p:cNvSpPr/>
            <p:nvPr/>
          </p:nvSpPr>
          <p:spPr>
            <a:xfrm>
              <a:off x="4419360" y="3744000"/>
              <a:ext cx="68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4"/>
            <p:cNvSpPr/>
            <p:nvPr/>
          </p:nvSpPr>
          <p:spPr>
            <a:xfrm>
              <a:off x="4433040" y="5663520"/>
              <a:ext cx="68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5"/>
            <p:cNvSpPr/>
            <p:nvPr/>
          </p:nvSpPr>
          <p:spPr>
            <a:xfrm>
              <a:off x="4392000" y="1852560"/>
              <a:ext cx="68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b25 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30T02:54:34Z</dcterms:created>
  <dc:creator>a</dc:creator>
  <dc:description/>
  <dc:language>en-US</dc:language>
  <cp:lastModifiedBy> </cp:lastModifiedBy>
  <dcterms:modified xsi:type="dcterms:W3CDTF">2014-01-28T12:47:15Z</dcterms:modified>
  <cp:revision>43</cp:revision>
  <dc:subject/>
  <dc:title>Slide 1</dc:title>
</cp:coreProperties>
</file>